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9926638" cy="143017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9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vente Kiss" userId="9fbb0f26-f9e0-428d-8b59-d3b09f9fc9b9" providerId="ADAL" clId="{63FFB1E9-B43F-4EFF-880C-A72297A246F8}"/>
    <pc:docChg chg="delSld">
      <pc:chgData name="Levente Kiss" userId="9fbb0f26-f9e0-428d-8b59-d3b09f9fc9b9" providerId="ADAL" clId="{63FFB1E9-B43F-4EFF-880C-A72297A246F8}" dt="2025-08-13T11:56:14.661" v="0" actId="47"/>
      <pc:docMkLst>
        <pc:docMk/>
      </pc:docMkLst>
      <pc:sldChg chg="del">
        <pc:chgData name="Levente Kiss" userId="9fbb0f26-f9e0-428d-8b59-d3b09f9fc9b9" providerId="ADAL" clId="{63FFB1E9-B43F-4EFF-880C-A72297A246F8}" dt="2025-08-13T11:56:14.661" v="0" actId="47"/>
        <pc:sldMkLst>
          <pc:docMk/>
          <pc:sldMk cId="2557287106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B84049-FE5D-3DE2-ACD8-5A449D7814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0BB125-E274-5F9D-65AB-AF4493C463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38A51-24FA-F7AD-A50A-8017D9164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75D3B-77D5-7C05-A5AA-88D128D78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6C5504-0DDB-A6F9-1136-79310CC70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1042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993AE-1A32-5E6D-C87B-A67A9F0528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389E2A-3C22-7DB9-FAFD-61342D2CD2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C2BF72-3982-2B71-DA6D-2F44F0321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03CB1-8117-71FD-4960-82602B6841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AE6449-7119-6733-57A0-1B0824EC59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95058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0F4463-8B9E-86E0-BC62-E0954E8B31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5D24A2-E836-D607-CA00-1DF92F6F28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70191E-330C-35DF-F4EF-A217CDA68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730555-EABD-4FED-DF76-504EF4778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4C99BE-A6B9-34F4-CCC7-27C556E05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5955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0378F4-5EA3-4992-46E7-B2ACE5F2FC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C1F1BC-565A-C81C-72AB-97295DA1D5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A50C5B-85CF-E60C-11F6-DE89872B7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C6FF65-3CC3-A21D-49B2-4DE442E61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C02700-7DD1-D2B1-5096-1892F3D50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3789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0E84CF-140F-87CD-CD84-C744AE66FB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326B80-AE09-3384-93BD-BC7AA2F1CB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FA03EF-3287-5C91-550B-AD746709A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86A0EE-FAEA-E9F1-14DB-EC2F39181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92F036-D2E7-01CD-EBEE-67070112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6293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44F13D-C198-A1EC-5C5D-FDDBD8E6B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200A13-4B38-92EA-10B0-DDB556AC78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3DE9D9-2E55-CFC7-26D7-AE8EAB5DBB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4B887-65F7-C4C4-F614-57C202AAF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2A4A97-E5F9-8831-DB90-155584A74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5AF9AD-0821-4227-5119-38EC79B60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5636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1C011-F399-FFAC-CCDE-8505D9E146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A376CC-3CB4-9BF8-A710-63E14ABC32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0F8697-5EA6-D8FD-2C45-6B5B599A4D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145B33-4ADB-B779-D0EF-EAA2D9FAE4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A76263-30DA-01A3-F8CB-D5D01B8809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58D387-313E-F28A-FF33-5156261FF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749A2E-2D75-A6D7-781E-5870FFD75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346DD3A-115B-509E-6556-1F068206A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8358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D4E317-61EC-B23B-DE87-22DE89E48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AE7954-FF0C-8078-1E7C-FE6F463D5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5C6E64-6398-F009-C2BE-19E177BC9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964FB9-290C-94C8-3E48-7D755AD9F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5845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F49087-8267-09A1-7517-C7DDF39F5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66D4BE-EADE-C651-CE16-BCE896210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8739569-4193-7858-7002-6E23934AD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8776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E167E6-1E8D-BD8F-3744-2943D23D7E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A87C3F-6299-7543-A3EF-C78E8EC98C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60A47D-3D4B-824E-8E45-CE71244033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3AF16D-B393-5965-975B-0B7A988B7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7F3773-8F60-640A-1186-F3AD68D4A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CDE807-536D-64BE-7D42-80B00A536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2017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4729E-A0BE-D2B4-EDD3-06B4501A1D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FDFD56-DE92-7C66-B9E8-F1196A003E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243645-0CA2-087D-9B67-769C7D59C0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4F8E90-8A5B-1369-2544-0B02E0981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FDA450-8E39-30AB-6A66-AAABDB69B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9E0858-7995-624F-D338-90AF4205C4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5659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2A122F-01C5-A09D-3158-57E62A8E1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C2760F-7369-B111-565F-55C0ABE200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215244-9883-7110-106A-70B1E785AA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2DFAA5-66BE-4ED4-87A4-FA7304B56CFE}" type="datetimeFigureOut">
              <a:rPr lang="en-AU" smtClean="0"/>
              <a:t>13/08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1FBD8E-603C-5E28-5090-1F63700AC8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C1137-F1C4-2493-C4D5-9EE576DD62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836EAE-372D-4D48-8D24-AED85DAD8DB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70233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Group 61">
            <a:extLst>
              <a:ext uri="{FF2B5EF4-FFF2-40B4-BE49-F238E27FC236}">
                <a16:creationId xmlns:a16="http://schemas.microsoft.com/office/drawing/2014/main" id="{9766998C-BBA4-B4B4-8A9E-FF48DBA29D91}"/>
              </a:ext>
            </a:extLst>
          </p:cNvPr>
          <p:cNvGrpSpPr/>
          <p:nvPr/>
        </p:nvGrpSpPr>
        <p:grpSpPr>
          <a:xfrm>
            <a:off x="48229" y="84905"/>
            <a:ext cx="13163275" cy="6688189"/>
            <a:chOff x="48229" y="84905"/>
            <a:chExt cx="13163275" cy="668818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6B57685-83BD-952F-6BE1-79F40AB4C2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3214" t="11587" r="14107" b="6826"/>
            <a:stretch>
              <a:fillRect/>
            </a:stretch>
          </p:blipFill>
          <p:spPr>
            <a:xfrm>
              <a:off x="48229" y="84905"/>
              <a:ext cx="10591799" cy="668818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87AE150-8E36-13C1-3816-805872DFCBD2}"/>
                </a:ext>
              </a:extLst>
            </p:cNvPr>
            <p:cNvSpPr txBox="1"/>
            <p:nvPr/>
          </p:nvSpPr>
          <p:spPr>
            <a:xfrm>
              <a:off x="1447041" y="84905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GYER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cu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arpinus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etulus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BB96017-D6CB-07E9-731E-9CFFA23583A3}"/>
                </a:ext>
              </a:extLst>
            </p:cNvPr>
            <p:cNvSpPr txBox="1"/>
            <p:nvPr/>
          </p:nvSpPr>
          <p:spPr>
            <a:xfrm>
              <a:off x="954463" y="200566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47b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EE1E3E9-02DC-4C25-3F00-ED04EBEED9A6}"/>
                </a:ext>
              </a:extLst>
            </p:cNvPr>
            <p:cNvSpPr txBox="1"/>
            <p:nvPr/>
          </p:nvSpPr>
          <p:spPr>
            <a:xfrm>
              <a:off x="2170942" y="316227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109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E9894DD-96AE-83E8-E1DE-03887A341C56}"/>
                </a:ext>
              </a:extLst>
            </p:cNvPr>
            <p:cNvSpPr txBox="1"/>
            <p:nvPr/>
          </p:nvSpPr>
          <p:spPr>
            <a:xfrm>
              <a:off x="2621338" y="431888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220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TALY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40DCAA6-36EC-8074-BE65-4D82F777DE1A}"/>
                </a:ext>
              </a:extLst>
            </p:cNvPr>
            <p:cNvSpPr txBox="1"/>
            <p:nvPr/>
          </p:nvSpPr>
          <p:spPr>
            <a:xfrm>
              <a:off x="700463" y="6144531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219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TALY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E3CD8D1-CD4F-3200-387C-2C243AADE8F7}"/>
                </a:ext>
              </a:extLst>
            </p:cNvPr>
            <p:cNvSpPr txBox="1"/>
            <p:nvPr/>
          </p:nvSpPr>
          <p:spPr>
            <a:xfrm>
              <a:off x="1527661" y="6260192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BRIP 72097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seudoidium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rtensiae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ydrangea macrophylla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AEE41EF-03F7-2AB5-6F1C-91161F422DCD}"/>
                </a:ext>
              </a:extLst>
            </p:cNvPr>
            <p:cNvSpPr txBox="1"/>
            <p:nvPr/>
          </p:nvSpPr>
          <p:spPr>
            <a:xfrm>
              <a:off x="7210272" y="549622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RU2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Rudbeckia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HUNGARY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64E3857-41EE-3F16-01BC-AD549B235271}"/>
                </a:ext>
              </a:extLst>
            </p:cNvPr>
            <p:cNvSpPr txBox="1"/>
            <p:nvPr/>
          </p:nvSpPr>
          <p:spPr>
            <a:xfrm>
              <a:off x="7214505" y="672389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RU4b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Rudbeckia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HUNGARY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E916A5A-F52A-D6BD-BD1E-EDF8DFDEC1EC}"/>
                </a:ext>
              </a:extLst>
            </p:cNvPr>
            <p:cNvSpPr txBox="1"/>
            <p:nvPr/>
          </p:nvSpPr>
          <p:spPr>
            <a:xfrm>
              <a:off x="6985906" y="904421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RU1b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Rudbeckia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HUNGARY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2942BBA-3E1A-B9B1-ABF4-FC7B60D149D6}"/>
                </a:ext>
              </a:extLst>
            </p:cNvPr>
            <p:cNvSpPr txBox="1"/>
            <p:nvPr/>
          </p:nvSpPr>
          <p:spPr>
            <a:xfrm>
              <a:off x="7086222" y="1027886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g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lumer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undetermined grass CZECHIA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5ED3782-BC51-DC1D-A946-718D847F8755}"/>
                </a:ext>
              </a:extLst>
            </p:cNvPr>
            <p:cNvSpPr txBox="1"/>
            <p:nvPr/>
          </p:nvSpPr>
          <p:spPr>
            <a:xfrm>
              <a:off x="7086222" y="1259220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grB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lumer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undetermined grass CZECHI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4322CA2-FA76-074F-ADCC-B7F1F3EB3AD7}"/>
                </a:ext>
              </a:extLst>
            </p:cNvPr>
            <p:cNvSpPr txBox="1"/>
            <p:nvPr/>
          </p:nvSpPr>
          <p:spPr>
            <a:xfrm>
              <a:off x="7086221" y="1493655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BgrC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lumer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undetermined grass CZECHI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7358C4B-67D8-2AD4-92E6-0913FD8FC8AC}"/>
                </a:ext>
              </a:extLst>
            </p:cNvPr>
            <p:cNvSpPr txBox="1"/>
            <p:nvPr/>
          </p:nvSpPr>
          <p:spPr>
            <a:xfrm>
              <a:off x="7082367" y="1145564"/>
              <a:ext cx="29123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0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USTRALI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FB4D164-CB3F-106F-1D00-951639F95ED0}"/>
                </a:ext>
              </a:extLst>
            </p:cNvPr>
            <p:cNvSpPr txBox="1"/>
            <p:nvPr/>
          </p:nvSpPr>
          <p:spPr>
            <a:xfrm>
              <a:off x="7082367" y="1377314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LS1a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ustralian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Lagerstroemi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sp. FRANCE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86486FA-6098-4279-7259-C0F414E26092}"/>
                </a:ext>
              </a:extLst>
            </p:cNvPr>
            <p:cNvSpPr txBox="1"/>
            <p:nvPr/>
          </p:nvSpPr>
          <p:spPr>
            <a:xfrm>
              <a:off x="7090075" y="1618739"/>
              <a:ext cx="315930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66222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seudoid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rtensiae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Hydrangea macrophyll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9DB71A72-694A-10E7-6C8A-2B5960A8FC7B}"/>
                </a:ext>
              </a:extLst>
            </p:cNvPr>
            <p:cNvSpPr txBox="1"/>
            <p:nvPr/>
          </p:nvSpPr>
          <p:spPr>
            <a:xfrm>
              <a:off x="7088153" y="1743823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5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E9A2214-0CB7-FF76-7FE8-0F1BA3DDB58A}"/>
                </a:ext>
              </a:extLst>
            </p:cNvPr>
            <p:cNvSpPr txBox="1"/>
            <p:nvPr/>
          </p:nvSpPr>
          <p:spPr>
            <a:xfrm>
              <a:off x="7090075" y="1860164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6212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Salvia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AUSTRALI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8384802-24C6-8CDD-79C1-D2A2A1FD0393}"/>
                </a:ext>
              </a:extLst>
            </p:cNvPr>
            <p:cNvSpPr txBox="1"/>
            <p:nvPr/>
          </p:nvSpPr>
          <p:spPr>
            <a:xfrm>
              <a:off x="7090075" y="1979461"/>
              <a:ext cx="29046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6211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sons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tramine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FD6915B-6EA0-915D-C166-6A8D95B0F075}"/>
                </a:ext>
              </a:extLst>
            </p:cNvPr>
            <p:cNvSpPr txBox="1"/>
            <p:nvPr/>
          </p:nvSpPr>
          <p:spPr>
            <a:xfrm>
              <a:off x="7082367" y="2101589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BRIP 72107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2C3A778-1CB9-80EF-3BAA-6112E7467AC0}"/>
                </a:ext>
              </a:extLst>
            </p:cNvPr>
            <p:cNvSpPr txBox="1"/>
            <p:nvPr/>
          </p:nvSpPr>
          <p:spPr>
            <a:xfrm>
              <a:off x="7082367" y="2217722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11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C6FFFDE-4B49-37DF-BBF9-A7AAC2CE0CE1}"/>
                </a:ext>
              </a:extLst>
            </p:cNvPr>
            <p:cNvSpPr txBox="1"/>
            <p:nvPr/>
          </p:nvSpPr>
          <p:spPr>
            <a:xfrm>
              <a:off x="7082367" y="2337227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9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A3251F2-E30D-ADD6-D9AC-D2A190F4EB75}"/>
                </a:ext>
              </a:extLst>
            </p:cNvPr>
            <p:cNvSpPr txBox="1"/>
            <p:nvPr/>
          </p:nvSpPr>
          <p:spPr>
            <a:xfrm>
              <a:off x="7082367" y="2453360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4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43F267F2-2794-8657-B953-8A950F18CBAE}"/>
                </a:ext>
              </a:extLst>
            </p:cNvPr>
            <p:cNvSpPr txBox="1"/>
            <p:nvPr/>
          </p:nvSpPr>
          <p:spPr>
            <a:xfrm>
              <a:off x="7082367" y="2561720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8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olay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estrum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qu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5D1B940-B91F-297E-A37A-7310A51720F5}"/>
                </a:ext>
              </a:extLst>
            </p:cNvPr>
            <p:cNvSpPr txBox="1"/>
            <p:nvPr/>
          </p:nvSpPr>
          <p:spPr>
            <a:xfrm>
              <a:off x="7086221" y="2677424"/>
              <a:ext cx="29046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6210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rsonsi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tramine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394AFD9-D453-FCBC-3102-4C5DE7DB5C58}"/>
                </a:ext>
              </a:extLst>
            </p:cNvPr>
            <p:cNvSpPr txBox="1"/>
            <p:nvPr/>
          </p:nvSpPr>
          <p:spPr>
            <a:xfrm>
              <a:off x="6428480" y="2814942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098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seudoid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rtensiae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Hydrangea macrophyll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AC58049-4F2A-E5A4-CA0E-F6EABF5EE672}"/>
                </a:ext>
              </a:extLst>
            </p:cNvPr>
            <p:cNvSpPr txBox="1"/>
            <p:nvPr/>
          </p:nvSpPr>
          <p:spPr>
            <a:xfrm>
              <a:off x="6428480" y="2925288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099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seudoid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ortensiae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Hydrangea macrophyll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80A57BB1-1756-E91A-8618-60F8D672426D}"/>
                </a:ext>
              </a:extLst>
            </p:cNvPr>
            <p:cNvSpPr txBox="1"/>
            <p:nvPr/>
          </p:nvSpPr>
          <p:spPr>
            <a:xfrm>
              <a:off x="5741715" y="3046556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225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655C609-D467-026D-DDAF-65A9C2CAC5F4}"/>
                </a:ext>
              </a:extLst>
            </p:cNvPr>
            <p:cNvSpPr txBox="1"/>
            <p:nvPr/>
          </p:nvSpPr>
          <p:spPr>
            <a:xfrm>
              <a:off x="5741715" y="3167824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347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TALY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447EC9A-BCD0-C7EF-FD79-851DE73FA262}"/>
                </a:ext>
              </a:extLst>
            </p:cNvPr>
            <p:cNvSpPr txBox="1"/>
            <p:nvPr/>
          </p:nvSpPr>
          <p:spPr>
            <a:xfrm>
              <a:off x="5741715" y="3289092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DSM 2222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ucumis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GERMANY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C6F2D69-211D-723A-CDDC-26B03E64E035}"/>
                </a:ext>
              </a:extLst>
            </p:cNvPr>
            <p:cNvSpPr txBox="1"/>
            <p:nvPr/>
          </p:nvSpPr>
          <p:spPr>
            <a:xfrm>
              <a:off x="6191338" y="5898513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29.79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ucurbita pepo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ANADA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59511A9-613C-36C4-0044-566233A8FC0E}"/>
                </a:ext>
              </a:extLst>
            </p:cNvPr>
            <p:cNvSpPr txBox="1"/>
            <p:nvPr/>
          </p:nvSpPr>
          <p:spPr>
            <a:xfrm>
              <a:off x="6199058" y="6017892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0.79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ucurbita pepo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ANAD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90BB434-3BB1-22AF-6D65-57CC831D56E5}"/>
                </a:ext>
              </a:extLst>
            </p:cNvPr>
            <p:cNvSpPr txBox="1"/>
            <p:nvPr/>
          </p:nvSpPr>
          <p:spPr>
            <a:xfrm>
              <a:off x="9666379" y="5794606"/>
              <a:ext cx="30371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MLAC 05119 </a:t>
              </a:r>
              <a:r>
                <a:rPr lang="en-AU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det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. powdery mildew ex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Youngia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japonica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CHINA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ABB953D-DB24-9F50-AED5-8CE05E5D58A5}"/>
                </a:ext>
              </a:extLst>
            </p:cNvPr>
            <p:cNvSpPr txBox="1"/>
            <p:nvPr/>
          </p:nvSpPr>
          <p:spPr>
            <a:xfrm>
              <a:off x="10030981" y="5667935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967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.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. radi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9DBC666-1AB2-C010-C22E-FF25BB160F71}"/>
                </a:ext>
              </a:extLst>
            </p:cNvPr>
            <p:cNvSpPr txBox="1"/>
            <p:nvPr/>
          </p:nvSpPr>
          <p:spPr>
            <a:xfrm>
              <a:off x="10403302" y="5431508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966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.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. radi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0C58370-845C-A0B3-06B6-82CE22372E31}"/>
                </a:ext>
              </a:extLst>
            </p:cNvPr>
            <p:cNvSpPr txBox="1"/>
            <p:nvPr/>
          </p:nvSpPr>
          <p:spPr>
            <a:xfrm>
              <a:off x="10403302" y="5541264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968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.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xanth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. radi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8B09C7F-8CEE-2959-9752-0AB2AD43E816}"/>
                </a:ext>
              </a:extLst>
            </p:cNvPr>
            <p:cNvSpPr txBox="1"/>
            <p:nvPr/>
          </p:nvSpPr>
          <p:spPr>
            <a:xfrm>
              <a:off x="9595845" y="5311669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2931A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FINLAND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4C6CB82-9411-8233-12C2-EDBF5C5A3408}"/>
                </a:ext>
              </a:extLst>
            </p:cNvPr>
            <p:cNvSpPr txBox="1"/>
            <p:nvPr/>
          </p:nvSpPr>
          <p:spPr>
            <a:xfrm>
              <a:off x="7441181" y="4833954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9031A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FINLAND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F535CEB-DB19-2772-48C9-7B55B706E57C}"/>
                </a:ext>
              </a:extLst>
            </p:cNvPr>
            <p:cNvSpPr txBox="1"/>
            <p:nvPr/>
          </p:nvSpPr>
          <p:spPr>
            <a:xfrm>
              <a:off x="7453692" y="4711261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3616A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FINLAND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360F22B-9271-E261-D35C-21FA10DBB2E0}"/>
                </a:ext>
              </a:extLst>
            </p:cNvPr>
            <p:cNvSpPr txBox="1"/>
            <p:nvPr/>
          </p:nvSpPr>
          <p:spPr>
            <a:xfrm>
              <a:off x="9384143" y="5070201"/>
              <a:ext cx="30178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BRIP 72102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47D023D-C03B-ED10-7224-B0549176AA7C}"/>
                </a:ext>
              </a:extLst>
            </p:cNvPr>
            <p:cNvSpPr txBox="1"/>
            <p:nvPr/>
          </p:nvSpPr>
          <p:spPr>
            <a:xfrm>
              <a:off x="9395717" y="4954882"/>
              <a:ext cx="30178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1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22D2B52-C197-3655-8B92-F7A3A16EAF68}"/>
                </a:ext>
              </a:extLst>
            </p:cNvPr>
            <p:cNvSpPr txBox="1"/>
            <p:nvPr/>
          </p:nvSpPr>
          <p:spPr>
            <a:xfrm>
              <a:off x="9391863" y="5188305"/>
              <a:ext cx="30178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03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lantagini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Plantago lanceolat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AUSTRALIA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59AD651-9145-7A5E-49E1-DB309A5022DA}"/>
                </a:ext>
              </a:extLst>
            </p:cNvPr>
            <p:cNvSpPr txBox="1"/>
            <p:nvPr/>
          </p:nvSpPr>
          <p:spPr>
            <a:xfrm>
              <a:off x="7453692" y="4588593"/>
              <a:ext cx="28082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263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Artemisia absinthi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CANADA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B7543B4-3235-3669-5F25-701ECC789189}"/>
                </a:ext>
              </a:extLst>
            </p:cNvPr>
            <p:cNvSpPr txBox="1"/>
            <p:nvPr/>
          </p:nvSpPr>
          <p:spPr>
            <a:xfrm>
              <a:off x="6813097" y="4478248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133.32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Lonicer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n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USA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5F5FBDDD-3F4C-E16D-7B55-DACAD44464D3}"/>
                </a:ext>
              </a:extLst>
            </p:cNvPr>
            <p:cNvSpPr txBox="1"/>
            <p:nvPr/>
          </p:nvSpPr>
          <p:spPr>
            <a:xfrm>
              <a:off x="9523034" y="4364529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2224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1C9B26B-982F-C0B4-08E3-EB556AA34190}"/>
                </a:ext>
              </a:extLst>
            </p:cNvPr>
            <p:cNvSpPr txBox="1"/>
            <p:nvPr/>
          </p:nvSpPr>
          <p:spPr>
            <a:xfrm>
              <a:off x="6944741" y="4235013"/>
              <a:ext cx="30371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Q10 Undetermined powdery mildew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Catha edulis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SRAEL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0EA1A79-AD42-E67D-6D8F-33A964313DDB}"/>
                </a:ext>
              </a:extLst>
            </p:cNvPr>
            <p:cNvSpPr txBox="1"/>
            <p:nvPr/>
          </p:nvSpPr>
          <p:spPr>
            <a:xfrm>
              <a:off x="7372941" y="4119292"/>
              <a:ext cx="2658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BRIP 72110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ustralian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Lagerstroemi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sp. AUSTRALIA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43FC35C-9D04-2BDD-1B33-CFA4E6EB8540}"/>
                </a:ext>
              </a:extLst>
            </p:cNvPr>
            <p:cNvSpPr txBox="1"/>
            <p:nvPr/>
          </p:nvSpPr>
          <p:spPr>
            <a:xfrm>
              <a:off x="7376906" y="3999311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RS1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odosphaer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annos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Ros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sp. HUNGARY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3847E7A5-E29B-5FC7-BE40-5AA5D8F9A4BA}"/>
                </a:ext>
              </a:extLst>
            </p:cNvPr>
            <p:cNvSpPr txBox="1"/>
            <p:nvPr/>
          </p:nvSpPr>
          <p:spPr>
            <a:xfrm>
              <a:off x="5303619" y="3403211"/>
              <a:ext cx="27689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TCC 201056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9534F62-1856-DC23-9C72-C09D693EDE6E}"/>
                </a:ext>
              </a:extLst>
            </p:cNvPr>
            <p:cNvSpPr txBox="1"/>
            <p:nvPr/>
          </p:nvSpPr>
          <p:spPr>
            <a:xfrm>
              <a:off x="5303618" y="3519374"/>
              <a:ext cx="27689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10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D59C889-47A0-2330-53D6-A3F2C3DF9DAC}"/>
                </a:ext>
              </a:extLst>
            </p:cNvPr>
            <p:cNvSpPr txBox="1"/>
            <p:nvPr/>
          </p:nvSpPr>
          <p:spPr>
            <a:xfrm>
              <a:off x="5303618" y="3647982"/>
              <a:ext cx="27689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A11a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throcladiella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ougeot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ycium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rum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HUNGARY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BCC04A1-1F0B-92A3-D03C-DB7EF1B840EA}"/>
                </a:ext>
              </a:extLst>
            </p:cNvPr>
            <p:cNvSpPr txBox="1"/>
            <p:nvPr/>
          </p:nvSpPr>
          <p:spPr>
            <a:xfrm>
              <a:off x="5305337" y="3765363"/>
              <a:ext cx="35709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Vitis79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ecator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Vitis vinifera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ITALY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91C1CE0-2DBE-F6BA-0310-DA9B9B8F44F2}"/>
                </a:ext>
              </a:extLst>
            </p:cNvPr>
            <p:cNvSpPr txBox="1"/>
            <p:nvPr/>
          </p:nvSpPr>
          <p:spPr>
            <a:xfrm>
              <a:off x="5311100" y="3879784"/>
              <a:ext cx="276896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Trb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Erysiphe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rifolii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Trifolium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HUNGARY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DC8AAA1-5993-F6F0-7893-0785A8737CD8}"/>
                </a:ext>
              </a:extLst>
            </p:cNvPr>
            <p:cNvSpPr txBox="1"/>
            <p:nvPr/>
          </p:nvSpPr>
          <p:spPr>
            <a:xfrm>
              <a:off x="7216058" y="791699"/>
              <a:ext cx="24329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CBS 131.31 </a:t>
              </a:r>
              <a:r>
                <a:rPr lang="en-AU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olovinomyces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sp. ex </a:t>
              </a:r>
              <a:r>
                <a:rPr lang="en-AU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H. tuberosus</a:t>
              </a:r>
              <a:r>
                <a:rPr lang="en-AU" sz="600" dirty="0">
                  <a:latin typeface="Arial" panose="020B0604020202020204" pitchFamily="34" charset="0"/>
                  <a:cs typeface="Arial" panose="020B0604020202020204" pitchFamily="34" charset="0"/>
                </a:rPr>
                <a:t> US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374799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b4fff8a3-050f-428f-b966-cc56f581f9b1}" enabled="1" method="Standard" siteId="{7dfbfb93-19b6-4985-ac7e-501a37938456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100</TotalTime>
  <Words>435</Words>
  <Application>Microsoft Office PowerPoint</Application>
  <PresentationFormat>Widescreen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University of Southern Queens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vente Kiss</dc:creator>
  <cp:lastModifiedBy>Levente Kiss</cp:lastModifiedBy>
  <cp:revision>2</cp:revision>
  <cp:lastPrinted>2025-07-31T01:07:17Z</cp:lastPrinted>
  <dcterms:created xsi:type="dcterms:W3CDTF">2025-07-29T14:43:21Z</dcterms:created>
  <dcterms:modified xsi:type="dcterms:W3CDTF">2025-08-13T11:56:25Z</dcterms:modified>
</cp:coreProperties>
</file>